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8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6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4893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6031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7957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27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4056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91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722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46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4236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8781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D09F-E0D2-4A2E-9150-F88ACD41947F}" type="datetimeFigureOut">
              <a:rPr lang="en-GB" smtClean="0"/>
              <a:t>09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21440-F9BB-4762-B31C-711CB3231F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534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452178" y="1632382"/>
            <a:ext cx="677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TB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5490278" y="3178460"/>
            <a:ext cx="261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QSTM1 (rabbit antibody)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5502978" y="3946485"/>
            <a:ext cx="2686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QSTM1 (mouse antibody)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5308162" y="1298650"/>
            <a:ext cx="26121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afA1 concentration (</a:t>
            </a:r>
            <a:r>
              <a:rPr lang="en-GB" dirty="0" err="1" smtClean="0"/>
              <a:t>nM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5428110" y="2441863"/>
            <a:ext cx="645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C3B</a:t>
            </a:r>
            <a:endParaRPr lang="en-GB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5291829" y="2629848"/>
            <a:ext cx="18574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H="1">
            <a:off x="5342629" y="3391848"/>
            <a:ext cx="18574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5368029" y="4141148"/>
            <a:ext cx="18574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129675" y="6311900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Supplementary Figure S3</a:t>
            </a:r>
            <a:endParaRPr lang="en-GB" sz="1400" b="1" dirty="0"/>
          </a:p>
        </p:txBody>
      </p:sp>
      <p:pic>
        <p:nvPicPr>
          <p:cNvPr id="38" name="Picture 5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3" t="16019" r="69560" b="79493"/>
          <a:stretch/>
        </p:blipFill>
        <p:spPr bwMode="auto">
          <a:xfrm>
            <a:off x="1827326" y="1586508"/>
            <a:ext cx="155976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9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15" t="82871" r="72272" b="10275"/>
          <a:stretch/>
        </p:blipFill>
        <p:spPr bwMode="auto">
          <a:xfrm>
            <a:off x="1827326" y="2234580"/>
            <a:ext cx="1559764" cy="590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" name="Picture 5"/>
          <p:cNvPicPr>
            <a:picLocks noChangeAspect="1" noChangeArrowheads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8" t="36388" r="68751" b="55741"/>
          <a:stretch/>
        </p:blipFill>
        <p:spPr bwMode="auto">
          <a:xfrm>
            <a:off x="1827325" y="3026668"/>
            <a:ext cx="1626827" cy="647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Picture 2" descr="C:\Users\mbzag\AppData\Local\Microsoft\Windows\Temporary Internet Files\Content.Outlook\M9Y4B8TM\200915b0001.jpg"/>
          <p:cNvPicPr>
            <a:picLocks noChangeAspect="1" noChangeArrowheads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72" t="85848" r="47547" b="7917"/>
          <a:stretch/>
        </p:blipFill>
        <p:spPr bwMode="auto">
          <a:xfrm>
            <a:off x="1849896" y="3890764"/>
            <a:ext cx="1604256" cy="6022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1854839" y="1226468"/>
            <a:ext cx="2103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    1     10     20</a:t>
            </a:r>
            <a:endParaRPr lang="en-GB" dirty="0"/>
          </a:p>
        </p:txBody>
      </p:sp>
      <p:sp>
        <p:nvSpPr>
          <p:cNvPr id="43" name="TextBox 42"/>
          <p:cNvSpPr txBox="1"/>
          <p:nvPr/>
        </p:nvSpPr>
        <p:spPr>
          <a:xfrm>
            <a:off x="3694421" y="1226468"/>
            <a:ext cx="1659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    1     10    20</a:t>
            </a:r>
            <a:endParaRPr lang="en-GB" dirty="0"/>
          </a:p>
        </p:txBody>
      </p:sp>
      <p:sp>
        <p:nvSpPr>
          <p:cNvPr id="44" name="TextBox 43"/>
          <p:cNvSpPr txBox="1"/>
          <p:nvPr/>
        </p:nvSpPr>
        <p:spPr>
          <a:xfrm>
            <a:off x="1900842" y="4459526"/>
            <a:ext cx="1553310" cy="2774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SC-34 lysates</a:t>
            </a:r>
            <a:endParaRPr lang="en-GB" dirty="0"/>
          </a:p>
        </p:txBody>
      </p:sp>
      <p:sp>
        <p:nvSpPr>
          <p:cNvPr id="45" name="TextBox 44"/>
          <p:cNvSpPr txBox="1"/>
          <p:nvPr/>
        </p:nvSpPr>
        <p:spPr>
          <a:xfrm>
            <a:off x="3598168" y="4457536"/>
            <a:ext cx="1338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HeLa lysates</a:t>
            </a:r>
            <a:endParaRPr lang="en-GB" dirty="0"/>
          </a:p>
        </p:txBody>
      </p:sp>
      <p:pic>
        <p:nvPicPr>
          <p:cNvPr id="46" name="Picture 5"/>
          <p:cNvPicPr>
            <a:picLocks noChangeAspect="1" noChangeArrowheads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97" t="36388" r="32115" b="55741"/>
          <a:stretch/>
        </p:blipFill>
        <p:spPr bwMode="auto">
          <a:xfrm>
            <a:off x="3598168" y="3026670"/>
            <a:ext cx="1659632" cy="647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2" descr="C:\Users\mbzag\AppData\Local\Microsoft\Windows\Temporary Internet Files\Content.Outlook\M9Y4B8TM\200915b0001.jpg"/>
          <p:cNvPicPr>
            <a:picLocks noChangeAspect="1" noChangeArrowheads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30" t="85979" r="13618" b="7917"/>
          <a:stretch/>
        </p:blipFill>
        <p:spPr bwMode="auto">
          <a:xfrm>
            <a:off x="3598168" y="3890764"/>
            <a:ext cx="1659632" cy="5895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077" t="82871" r="37306" b="10275"/>
          <a:stretch/>
        </p:blipFill>
        <p:spPr bwMode="auto">
          <a:xfrm>
            <a:off x="3598168" y="2234580"/>
            <a:ext cx="1659632" cy="590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5"/>
          <p:cNvPicPr>
            <a:picLocks noChangeAspect="1" noChangeArrowheads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22" t="16019" r="34114" b="79493"/>
          <a:stretch/>
        </p:blipFill>
        <p:spPr bwMode="auto">
          <a:xfrm>
            <a:off x="3598169" y="1586508"/>
            <a:ext cx="16596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0" name="Straight Arrow Connector 49"/>
          <p:cNvCxnSpPr/>
          <p:nvPr/>
        </p:nvCxnSpPr>
        <p:spPr>
          <a:xfrm flipH="1">
            <a:off x="5342629" y="1842448"/>
            <a:ext cx="18574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3028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ode Alice</dc:creator>
  <cp:lastModifiedBy>Goode Alice</cp:lastModifiedBy>
  <cp:revision>1</cp:revision>
  <dcterms:created xsi:type="dcterms:W3CDTF">2016-03-09T19:45:33Z</dcterms:created>
  <dcterms:modified xsi:type="dcterms:W3CDTF">2016-03-09T19:45:55Z</dcterms:modified>
</cp:coreProperties>
</file>